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2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E97B6A-A86D-B404-431E-1F4C364067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489EC5-76D4-FEE7-825C-A5E5205D35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2633EB5-F03C-E2DA-CBDE-47D6C5522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870134-8663-26C3-7F9E-279E0F646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E4FF1C-5771-EA3C-BF88-46464FA14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677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488CA3-42A0-3320-E431-ABE592FB7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D62D56-6E5A-B14C-2837-F20BA4C0A3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B5BEE9-D3BE-A536-6049-A79FD653E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AE5B7B-862A-8F6E-6932-294816DE5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C080B9-E370-E4D3-0648-EDAEA6B71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07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26E7BDD-D47F-7420-02C3-6316BA3D76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F05FBF-51F6-FA4D-48E7-082BA62FC8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994B58-FB98-CB12-A65C-765BDBE80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69A404-D2D8-CBFC-A287-8E23E3B10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78DB75-9C29-FE4F-47EE-AA9459D0D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3079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AEA8A1-09F7-146F-F32E-310CE63CCF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E8E9E8-8B48-3BA4-C064-B077A0D246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84BB77-C615-1D0F-C167-4080403E3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02AC40-C145-DF59-6A37-A586338E5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E605F7-B284-E458-92BB-1FD64A3C6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954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7E24AB-92F1-CA76-DA05-938B5AEB9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BF55DEE-426C-8E3A-8198-E711AC69B8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761B6E-D7AD-7754-2EA9-8950AD227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E20E54-E0A4-96A1-EA31-A7E33E2F9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665950-664D-7DF8-205B-E86FE13A1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9148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804F35-AF46-4199-13B9-B8A0AB9EE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AE76FD0-DC99-743A-5DDF-0347E9C4D5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BD64DE-62DD-A07A-98DB-FEB7E86250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EF9CAE-0156-3FB9-CC23-85FB3DB6C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DC1F301-8B62-48BC-A516-A42F61B92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741ACF-B409-B6AF-5FAB-4DDBB1CE0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6128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1D91F3-6E13-042B-1482-DE419FC81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8F62D2C-6B82-B369-31CA-28C5362E01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08851E-12D3-3CB1-DB16-1523AEDDC7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B94BAA2-B05A-F768-C243-D9577125C2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538C30-1D59-157E-0D23-56B1D23D26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584B231-C173-C321-35CF-A15A4387D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A244BDD-188B-F9CC-1EA7-D4BFB2081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C9864CA-EBD9-733C-8892-87CA8E695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2013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604F49-4555-EF17-E237-DC3BBA7AA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11FAA8-60BC-0516-4430-35B33EF56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FC2FAB4-48D2-4B5F-D5CC-0DA03EFD6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763F5F2-52A1-5139-901E-2E074A7DA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320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D17730-6267-9F7B-52A0-E0A06982E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C7A2D66-82FC-EDAA-94D1-812C807C1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7D1D30A-8568-7524-F433-A31C9E07A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665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3C4BC1-5030-71DB-9370-17FA3CA29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68ABE3-67AB-E940-48A2-6630F9D848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A724B7-8352-D6AE-1F12-8DCD7E79A9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A7265C3-E62A-9A40-856D-D9636A646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3DF14D1-7412-BB5B-1B3B-73533D577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B623D2-B3E3-7A2A-9FB7-B05FF756F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8729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65FFDE-3935-BCFD-1CED-81E0E1F12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4E36B9F-9F05-5B32-F534-AC27D72A63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7E6251C-E02B-A2A1-A3C6-A34053940D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69BE5A6-F008-D189-8890-0885F3269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BB243EB-22FC-BE5F-521B-2BEB1271C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EE80FC-5DB6-A8AD-0BDC-006029CC0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6861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AAE0404-9289-5442-D843-ECAB7849C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0C6268-F3E1-5E0D-4CBA-340F791CA9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D9A829-517A-DB68-D79C-A01C8B7DEE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14A6F-E16F-4E7F-9F10-1640C22AEAFC}" type="datetimeFigureOut">
              <a:rPr lang="zh-CN" altLang="en-US" smtClean="0"/>
              <a:t>2025/7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22ADD7-125E-499E-A2E7-EE2D715A5F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2757A5-9CCD-D6ED-0D40-FBF2387D48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C8286-A2CB-4D44-8927-E873A3C3EF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3633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C849E37-8F0B-4A0A-5E7D-603D16B1C268}"/>
              </a:ext>
            </a:extLst>
          </p:cNvPr>
          <p:cNvSpPr txBox="1"/>
          <p:nvPr/>
        </p:nvSpPr>
        <p:spPr>
          <a:xfrm>
            <a:off x="7241242" y="1362333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5EB033B-9EB3-09F3-AB08-1F5056670B87}"/>
              </a:ext>
            </a:extLst>
          </p:cNvPr>
          <p:cNvSpPr txBox="1"/>
          <p:nvPr/>
        </p:nvSpPr>
        <p:spPr>
          <a:xfrm>
            <a:off x="7120246" y="3256827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58D77765-A4FD-6931-78B8-1EC1B1261515}"/>
              </a:ext>
            </a:extLst>
          </p:cNvPr>
          <p:cNvCxnSpPr/>
          <p:nvPr/>
        </p:nvCxnSpPr>
        <p:spPr>
          <a:xfrm>
            <a:off x="6425586" y="338378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B850690-4C92-5B9B-B280-50966E831952}"/>
              </a:ext>
            </a:extLst>
          </p:cNvPr>
          <p:cNvCxnSpPr/>
          <p:nvPr/>
        </p:nvCxnSpPr>
        <p:spPr>
          <a:xfrm>
            <a:off x="6546582" y="1489992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E7451812-D6E2-B5B9-E4FD-1C29662E7B16}"/>
              </a:ext>
            </a:extLst>
          </p:cNvPr>
          <p:cNvSpPr txBox="1"/>
          <p:nvPr/>
        </p:nvSpPr>
        <p:spPr>
          <a:xfrm>
            <a:off x="7241242" y="166516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C7C7F2FE-D977-B52E-35EF-1EF1FC0CF2E6}"/>
              </a:ext>
            </a:extLst>
          </p:cNvPr>
          <p:cNvCxnSpPr/>
          <p:nvPr/>
        </p:nvCxnSpPr>
        <p:spPr>
          <a:xfrm>
            <a:off x="6546582" y="174250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图片 13">
            <a:extLst>
              <a:ext uri="{FF2B5EF4-FFF2-40B4-BE49-F238E27FC236}">
                <a16:creationId xmlns:a16="http://schemas.microsoft.com/office/drawing/2014/main" id="{EB9932A5-B52C-2119-9445-781B7D343B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05" t="44173" r="40852" b="43106"/>
          <a:stretch>
            <a:fillRect/>
          </a:stretch>
        </p:blipFill>
        <p:spPr>
          <a:xfrm flipH="1">
            <a:off x="3270435" y="2709530"/>
            <a:ext cx="3104707" cy="188352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0F733F9-A858-D52A-1448-3C4B7C85B5B1}"/>
              </a:ext>
            </a:extLst>
          </p:cNvPr>
          <p:cNvSpPr txBox="1"/>
          <p:nvPr/>
        </p:nvSpPr>
        <p:spPr>
          <a:xfrm>
            <a:off x="7241241" y="404718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9238D57-9A27-2A58-0766-FF1F87C74484}"/>
              </a:ext>
            </a:extLst>
          </p:cNvPr>
          <p:cNvCxnSpPr/>
          <p:nvPr/>
        </p:nvCxnSpPr>
        <p:spPr>
          <a:xfrm>
            <a:off x="6462404" y="417413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1CF98C7-0C1C-0C86-AEB2-569526DB5429}"/>
              </a:ext>
            </a:extLst>
          </p:cNvPr>
          <p:cNvSpPr txBox="1"/>
          <p:nvPr/>
        </p:nvSpPr>
        <p:spPr>
          <a:xfrm>
            <a:off x="2254572" y="1306259"/>
            <a:ext cx="8962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HOXA5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10B13912-EAAC-8140-4062-B6BF170E50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17" t="45975" r="40097" b="38037"/>
          <a:stretch>
            <a:fillRect/>
          </a:stretch>
        </p:blipFill>
        <p:spPr>
          <a:xfrm flipH="1">
            <a:off x="3391763" y="349953"/>
            <a:ext cx="3033823" cy="2280078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C686673A-9B4E-4DBD-51DD-8A4BA51A8196}"/>
              </a:ext>
            </a:extLst>
          </p:cNvPr>
          <p:cNvSpPr txBox="1"/>
          <p:nvPr/>
        </p:nvSpPr>
        <p:spPr>
          <a:xfrm>
            <a:off x="2254572" y="3663143"/>
            <a:ext cx="8962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7E8441D-4489-93B5-A0A8-DA651BE5D0EB}"/>
              </a:ext>
            </a:extLst>
          </p:cNvPr>
          <p:cNvSpPr txBox="1"/>
          <p:nvPr/>
        </p:nvSpPr>
        <p:spPr>
          <a:xfrm rot="18332863">
            <a:off x="3480367" y="4784371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2274153-3F4C-FDB3-09E8-35CEBCAB21C5}"/>
              </a:ext>
            </a:extLst>
          </p:cNvPr>
          <p:cNvSpPr txBox="1"/>
          <p:nvPr/>
        </p:nvSpPr>
        <p:spPr>
          <a:xfrm rot="18332863">
            <a:off x="3871578" y="4914732"/>
            <a:ext cx="92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HOXA5-1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DDC4A41-F7F9-459A-3BBD-D025C285AA06}"/>
              </a:ext>
            </a:extLst>
          </p:cNvPr>
          <p:cNvSpPr txBox="1"/>
          <p:nvPr/>
        </p:nvSpPr>
        <p:spPr>
          <a:xfrm rot="18332863">
            <a:off x="4702144" y="4914731"/>
            <a:ext cx="92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HOXA5-2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E9CE65A-F7D1-6650-98CC-FBD036FB3AC3}"/>
              </a:ext>
            </a:extLst>
          </p:cNvPr>
          <p:cNvSpPr txBox="1"/>
          <p:nvPr/>
        </p:nvSpPr>
        <p:spPr>
          <a:xfrm>
            <a:off x="4107971" y="5759022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KG-1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0045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4BDB74-1645-91FA-86E8-DB7162ECB5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358D14B-140B-40DF-3B81-5C7E90E3A6A2}"/>
              </a:ext>
            </a:extLst>
          </p:cNvPr>
          <p:cNvSpPr txBox="1"/>
          <p:nvPr/>
        </p:nvSpPr>
        <p:spPr>
          <a:xfrm>
            <a:off x="1884427" y="1130659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239B131-C6AC-6268-1744-E1BE64B6BE26}"/>
              </a:ext>
            </a:extLst>
          </p:cNvPr>
          <p:cNvSpPr txBox="1"/>
          <p:nvPr/>
        </p:nvSpPr>
        <p:spPr>
          <a:xfrm>
            <a:off x="1926708" y="3489730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72DE001F-4D4F-844A-A924-A257E62D5176}"/>
              </a:ext>
            </a:extLst>
          </p:cNvPr>
          <p:cNvCxnSpPr/>
          <p:nvPr/>
        </p:nvCxnSpPr>
        <p:spPr>
          <a:xfrm>
            <a:off x="2576600" y="3616688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14E6652-4E16-27C5-1130-35A3D74EB445}"/>
              </a:ext>
            </a:extLst>
          </p:cNvPr>
          <p:cNvCxnSpPr/>
          <p:nvPr/>
        </p:nvCxnSpPr>
        <p:spPr>
          <a:xfrm>
            <a:off x="2445934" y="1275049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FF4E325F-CE66-F919-40ED-829FB11B148B}"/>
              </a:ext>
            </a:extLst>
          </p:cNvPr>
          <p:cNvSpPr txBox="1"/>
          <p:nvPr/>
        </p:nvSpPr>
        <p:spPr>
          <a:xfrm>
            <a:off x="1850511" y="1805066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9B6637AB-ED9A-8D72-3E89-2364F1071530}"/>
              </a:ext>
            </a:extLst>
          </p:cNvPr>
          <p:cNvCxnSpPr/>
          <p:nvPr/>
        </p:nvCxnSpPr>
        <p:spPr>
          <a:xfrm>
            <a:off x="2378572" y="1932024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660E45BB-A6C5-455F-B9D8-0AEAD0138844}"/>
              </a:ext>
            </a:extLst>
          </p:cNvPr>
          <p:cNvSpPr txBox="1"/>
          <p:nvPr/>
        </p:nvSpPr>
        <p:spPr>
          <a:xfrm>
            <a:off x="1981177" y="3968927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30kDa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9A6EEB3D-B61B-CF7F-8C20-43142FAAC9D1}"/>
              </a:ext>
            </a:extLst>
          </p:cNvPr>
          <p:cNvCxnSpPr/>
          <p:nvPr/>
        </p:nvCxnSpPr>
        <p:spPr>
          <a:xfrm>
            <a:off x="2576600" y="4095885"/>
            <a:ext cx="6946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4D8669D7-EFC6-39E8-2D98-12F396CFA0D2}"/>
              </a:ext>
            </a:extLst>
          </p:cNvPr>
          <p:cNvSpPr txBox="1"/>
          <p:nvPr/>
        </p:nvSpPr>
        <p:spPr>
          <a:xfrm>
            <a:off x="5804587" y="1398492"/>
            <a:ext cx="8962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HOXA5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8DB6419-C0C5-724D-2A1E-600A213C99CA}"/>
              </a:ext>
            </a:extLst>
          </p:cNvPr>
          <p:cNvSpPr txBox="1"/>
          <p:nvPr/>
        </p:nvSpPr>
        <p:spPr>
          <a:xfrm>
            <a:off x="6361629" y="3616688"/>
            <a:ext cx="89620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D92B8A6-25A4-D143-7B4D-A85A17641FCE}"/>
              </a:ext>
            </a:extLst>
          </p:cNvPr>
          <p:cNvSpPr txBox="1"/>
          <p:nvPr/>
        </p:nvSpPr>
        <p:spPr>
          <a:xfrm rot="18332863">
            <a:off x="3480367" y="4784371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NC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21268F8-1A2C-4A92-B187-6EF7B8CF759E}"/>
              </a:ext>
            </a:extLst>
          </p:cNvPr>
          <p:cNvSpPr txBox="1"/>
          <p:nvPr/>
        </p:nvSpPr>
        <p:spPr>
          <a:xfrm rot="18332863">
            <a:off x="3871578" y="4914732"/>
            <a:ext cx="92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HOXA5-1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59EAE1D-1E98-0B13-367F-D8E5E7B0B5BC}"/>
              </a:ext>
            </a:extLst>
          </p:cNvPr>
          <p:cNvSpPr txBox="1"/>
          <p:nvPr/>
        </p:nvSpPr>
        <p:spPr>
          <a:xfrm rot="18332863">
            <a:off x="4702144" y="4914731"/>
            <a:ext cx="92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siHOXA5-2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583C0B9-3146-FA04-F19A-69F7BA8F64A6}"/>
              </a:ext>
            </a:extLst>
          </p:cNvPr>
          <p:cNvSpPr txBox="1"/>
          <p:nvPr/>
        </p:nvSpPr>
        <p:spPr>
          <a:xfrm>
            <a:off x="4107971" y="5759022"/>
            <a:ext cx="59542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>
                <a:latin typeface="Arial" panose="020B0604020202020204" pitchFamily="34" charset="0"/>
                <a:cs typeface="Arial" panose="020B0604020202020204" pitchFamily="34" charset="0"/>
              </a:rPr>
              <a:t>U937</a:t>
            </a:r>
            <a:endParaRPr lang="zh-CN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6746D81-715C-96F7-7BC4-73131DC0F7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23" t="46213" r="37934" b="39125"/>
          <a:stretch>
            <a:fillRect/>
          </a:stretch>
        </p:blipFill>
        <p:spPr>
          <a:xfrm>
            <a:off x="3330704" y="2961328"/>
            <a:ext cx="2921988" cy="167333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7BE230A-5B98-649C-7BC4-64483DB3E4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39" t="46918" r="41258" b="41268"/>
          <a:stretch>
            <a:fillRect/>
          </a:stretch>
        </p:blipFill>
        <p:spPr>
          <a:xfrm>
            <a:off x="3330704" y="892875"/>
            <a:ext cx="2352257" cy="1344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481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0</Words>
  <Application>Microsoft Office PowerPoint</Application>
  <PresentationFormat>宽屏</PresentationFormat>
  <Paragraphs>2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 Ruiping</dc:creator>
  <cp:lastModifiedBy>H Ruiping</cp:lastModifiedBy>
  <cp:revision>1</cp:revision>
  <dcterms:created xsi:type="dcterms:W3CDTF">2025-07-25T05:56:32Z</dcterms:created>
  <dcterms:modified xsi:type="dcterms:W3CDTF">2025-07-25T06:13:16Z</dcterms:modified>
</cp:coreProperties>
</file>